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93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4597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2605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734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112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17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728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3513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544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566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7706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593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094C9-6337-4D2D-BEDD-3496E3210863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E4C077-0F5B-413B-8FB2-E88BD827A1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5220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2988297"/>
              </p:ext>
            </p:extLst>
          </p:nvPr>
        </p:nvGraphicFramePr>
        <p:xfrm>
          <a:off x="452695" y="2318164"/>
          <a:ext cx="11512668" cy="283423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389573">
                  <a:extLst>
                    <a:ext uri="{9D8B030D-6E8A-4147-A177-3AD203B41FA5}">
                      <a16:colId xmlns:a16="http://schemas.microsoft.com/office/drawing/2014/main" val="1338520675"/>
                    </a:ext>
                  </a:extLst>
                </a:gridCol>
                <a:gridCol w="1127173">
                  <a:extLst>
                    <a:ext uri="{9D8B030D-6E8A-4147-A177-3AD203B41FA5}">
                      <a16:colId xmlns:a16="http://schemas.microsoft.com/office/drawing/2014/main" val="2108944244"/>
                    </a:ext>
                  </a:extLst>
                </a:gridCol>
                <a:gridCol w="1417254">
                  <a:extLst>
                    <a:ext uri="{9D8B030D-6E8A-4147-A177-3AD203B41FA5}">
                      <a16:colId xmlns:a16="http://schemas.microsoft.com/office/drawing/2014/main" val="3996361407"/>
                    </a:ext>
                  </a:extLst>
                </a:gridCol>
                <a:gridCol w="1644667">
                  <a:extLst>
                    <a:ext uri="{9D8B030D-6E8A-4147-A177-3AD203B41FA5}">
                      <a16:colId xmlns:a16="http://schemas.microsoft.com/office/drawing/2014/main" val="1353174794"/>
                    </a:ext>
                  </a:extLst>
                </a:gridCol>
                <a:gridCol w="1957119">
                  <a:extLst>
                    <a:ext uri="{9D8B030D-6E8A-4147-A177-3AD203B41FA5}">
                      <a16:colId xmlns:a16="http://schemas.microsoft.com/office/drawing/2014/main" val="2506337180"/>
                    </a:ext>
                  </a:extLst>
                </a:gridCol>
                <a:gridCol w="1480212">
                  <a:extLst>
                    <a:ext uri="{9D8B030D-6E8A-4147-A177-3AD203B41FA5}">
                      <a16:colId xmlns:a16="http://schemas.microsoft.com/office/drawing/2014/main" val="1372377285"/>
                    </a:ext>
                  </a:extLst>
                </a:gridCol>
                <a:gridCol w="1496670">
                  <a:extLst>
                    <a:ext uri="{9D8B030D-6E8A-4147-A177-3AD203B41FA5}">
                      <a16:colId xmlns:a16="http://schemas.microsoft.com/office/drawing/2014/main" val="6136771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cy</a:t>
                      </a:r>
                      <a:endParaRPr lang="en-GB" sz="1000" b="1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Q1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 69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Ts/Week</a:t>
                      </a:r>
                      <a:endParaRPr lang="en-GB" sz="1000" b="1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39690" marR="3969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Q2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93 – 1520 METs/Week</a:t>
                      </a:r>
                      <a:endParaRPr lang="en-GB" sz="1000" b="1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39690" marR="3969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Q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21– 2978</a:t>
                      </a:r>
                      <a:endParaRPr lang="en-GB" sz="1000" b="1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s-ES" sz="1000" b="1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/</a:t>
                      </a:r>
                      <a:r>
                        <a:rPr lang="es-ES" sz="1000" b="1" dirty="0" err="1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Week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39690" marR="3969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n-U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Q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b="1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2978</a:t>
                      </a:r>
                      <a:endParaRPr lang="en-GB" sz="1000" b="1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METs</a:t>
                      </a:r>
                      <a:r>
                        <a:rPr lang="es-ES" sz="1000" b="1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/</a:t>
                      </a:r>
                      <a:r>
                        <a:rPr lang="es-ES" sz="1000" b="1" dirty="0" err="1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Week</a:t>
                      </a:r>
                      <a:endParaRPr lang="en-GB" sz="1000" b="1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39690" marR="3969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P </a:t>
                      </a:r>
                      <a:r>
                        <a:rPr lang="es-ES" sz="1000" b="1" dirty="0" err="1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value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39690" marR="3969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735725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retinopathy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 (69.0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8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3.6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73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9.5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0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75.5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71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7.6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716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– proliferative </a:t>
                      </a: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inopathy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(17.5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20.6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20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2 (11.3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8  (17.1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352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81867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ve  Retinopathy/ME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(13.5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17 (15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9.5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4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13.2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6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15.2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311000"/>
                  </a:ext>
                </a:extLst>
              </a:tr>
              <a:tr h="2625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phropathy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(11.3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11.2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2.4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1.3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1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0.5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979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21884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yneuropathy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(8.0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3 (12.2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1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10.5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.6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060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964522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ovascular disease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4.5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9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8.4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6 (5.7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057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20098031"/>
                  </a:ext>
                </a:extLst>
              </a:tr>
              <a:tr h="3002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ke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0.2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-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-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-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-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99801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ic foot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.6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4.7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1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2  (1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2 (1.9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488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58959416"/>
                  </a:ext>
                </a:extLst>
              </a:tr>
              <a:tr h="19973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complications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9 (79.8%)</a:t>
                      </a:r>
                      <a:endParaRPr lang="en-GB" sz="1000" b="0" dirty="0" smtClean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5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79.4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0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76.2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7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(82.1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7</a:t>
                      </a:r>
                      <a:r>
                        <a:rPr lang="en-GB" sz="1000" b="0" baseline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82.8%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Arial" panose="020B0604020202020204" pitchFamily="34" charset="0"/>
                          <a:ea typeface="MS Mincho"/>
                          <a:cs typeface="Arial" panose="020B0604020202020204" pitchFamily="34" charset="0"/>
                        </a:rPr>
                        <a:t>0.615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0522197"/>
                  </a:ext>
                </a:extLst>
              </a:tr>
            </a:tbl>
          </a:graphicData>
        </a:graphic>
      </p:graphicFrame>
      <p:sp>
        <p:nvSpPr>
          <p:cNvPr id="5" name="CuadroTexto 4"/>
          <p:cNvSpPr txBox="1"/>
          <p:nvPr/>
        </p:nvSpPr>
        <p:spPr>
          <a:xfrm>
            <a:off x="207818" y="384464"/>
            <a:ext cx="416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Material S1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65770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4</Words>
  <Application>Microsoft Office PowerPoint</Application>
  <PresentationFormat>Panorámica</PresentationFormat>
  <Paragraphs>7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Mincho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</dc:creator>
  <cp:lastModifiedBy>Fernando</cp:lastModifiedBy>
  <cp:revision>4</cp:revision>
  <dcterms:created xsi:type="dcterms:W3CDTF">2025-07-22T12:16:51Z</dcterms:created>
  <dcterms:modified xsi:type="dcterms:W3CDTF">2026-01-28T11:24:57Z</dcterms:modified>
</cp:coreProperties>
</file>